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9144000" cy="6858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98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0A545302-2B77-4B27-879C-E2938CE1C4BE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00FF5A2A-FAA2-4263-826D-44E0F45096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581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065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27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6499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85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0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412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261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229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960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19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268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16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8" name="直線コネクタ 17"/>
          <p:cNvCxnSpPr/>
          <p:nvPr/>
        </p:nvCxnSpPr>
        <p:spPr>
          <a:xfrm>
            <a:off x="1404571" y="2141470"/>
            <a:ext cx="648072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7700115" y="2267687"/>
            <a:ext cx="13843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2,741 nucleotides</a:t>
            </a:r>
            <a:endParaRPr kumimoji="1" lang="ja-JP" altLang="en-US" sz="16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23" name="直線コネクタ 22"/>
          <p:cNvCxnSpPr/>
          <p:nvPr/>
        </p:nvCxnSpPr>
        <p:spPr>
          <a:xfrm>
            <a:off x="1404571" y="1372385"/>
            <a:ext cx="122413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3299789" y="1447094"/>
            <a:ext cx="2088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,729 nucleotides</a:t>
            </a:r>
            <a:endParaRPr kumimoji="1" lang="ja-JP" altLang="en-US" sz="16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" name="四角形吹き出し 2"/>
          <p:cNvSpPr/>
          <p:nvPr/>
        </p:nvSpPr>
        <p:spPr>
          <a:xfrm rot="10800000">
            <a:off x="251519" y="3338854"/>
            <a:ext cx="2835199" cy="1380694"/>
          </a:xfrm>
          <a:prstGeom prst="wedgeRectCallout">
            <a:avLst>
              <a:gd name="adj1" fmla="val -18856"/>
              <a:gd name="adj2" fmla="val 72259"/>
            </a:avLst>
          </a:prstGeom>
          <a:solidFill>
            <a:schemeClr val="bg1">
              <a:lumMod val="9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73" name="グループ化 72"/>
          <p:cNvGrpSpPr/>
          <p:nvPr/>
        </p:nvGrpSpPr>
        <p:grpSpPr>
          <a:xfrm>
            <a:off x="755576" y="3720813"/>
            <a:ext cx="1812900" cy="612484"/>
            <a:chOff x="1164149" y="3501008"/>
            <a:chExt cx="1812900" cy="612484"/>
          </a:xfrm>
        </p:grpSpPr>
        <p:sp>
          <p:nvSpPr>
            <p:cNvPr id="87" name="テキスト ボックス 86"/>
            <p:cNvSpPr txBox="1"/>
            <p:nvPr/>
          </p:nvSpPr>
          <p:spPr>
            <a:xfrm>
              <a:off x="1176849" y="3501008"/>
              <a:ext cx="1800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A</a:t>
              </a:r>
              <a:r>
                <a:rPr lang="en-US" altLang="ja-JP" sz="1750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UUUUU</a:t>
              </a:r>
              <a:endParaRPr kumimoji="1" lang="ja-JP" altLang="en-US" sz="1750" dirty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88" name="テキスト ボックス 87"/>
            <p:cNvSpPr txBox="1"/>
            <p:nvPr/>
          </p:nvSpPr>
          <p:spPr>
            <a:xfrm>
              <a:off x="1164149" y="3728771"/>
              <a:ext cx="1800200" cy="3847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U</a:t>
              </a:r>
              <a:r>
                <a:rPr lang="en-US" altLang="ja-JP" sz="1900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AAAAA</a:t>
              </a:r>
              <a:endParaRPr kumimoji="1" lang="ja-JP" altLang="en-US" sz="1900" dirty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sp>
        <p:nvSpPr>
          <p:cNvPr id="74" name="テキスト ボックス 73"/>
          <p:cNvSpPr txBox="1"/>
          <p:nvPr/>
        </p:nvSpPr>
        <p:spPr>
          <a:xfrm>
            <a:off x="1739581" y="3547946"/>
            <a:ext cx="523695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9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1931057" y="3354625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2209575" y="3317681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2467074" y="3495545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2621434" y="3768543"/>
            <a:ext cx="57606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2460724" y="4064045"/>
            <a:ext cx="32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2264537" y="4279880"/>
            <a:ext cx="57606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1983065" y="4288267"/>
            <a:ext cx="316680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1739374" y="4116056"/>
            <a:ext cx="35268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83" name="直線コネクタ 82"/>
          <p:cNvCxnSpPr/>
          <p:nvPr/>
        </p:nvCxnSpPr>
        <p:spPr>
          <a:xfrm>
            <a:off x="647312" y="3912403"/>
            <a:ext cx="1471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/>
          <p:cNvCxnSpPr/>
          <p:nvPr/>
        </p:nvCxnSpPr>
        <p:spPr>
          <a:xfrm>
            <a:off x="654193" y="4133242"/>
            <a:ext cx="1471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/>
          <p:cNvSpPr txBox="1"/>
          <p:nvPr/>
        </p:nvSpPr>
        <p:spPr>
          <a:xfrm>
            <a:off x="323528" y="3696306"/>
            <a:ext cx="1044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5’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329212" y="3941066"/>
            <a:ext cx="949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’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6" name="四角形吹き出し 105"/>
          <p:cNvSpPr/>
          <p:nvPr/>
        </p:nvSpPr>
        <p:spPr>
          <a:xfrm rot="10800000">
            <a:off x="3197497" y="3336731"/>
            <a:ext cx="2617543" cy="1380694"/>
          </a:xfrm>
          <a:prstGeom prst="wedgeRectCallout">
            <a:avLst>
              <a:gd name="adj1" fmla="val 10799"/>
              <a:gd name="adj2" fmla="val 71563"/>
            </a:avLst>
          </a:prstGeom>
          <a:solidFill>
            <a:schemeClr val="bg1">
              <a:lumMod val="9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58" name="グループ化 57"/>
          <p:cNvGrpSpPr/>
          <p:nvPr/>
        </p:nvGrpSpPr>
        <p:grpSpPr>
          <a:xfrm>
            <a:off x="3688854" y="3742014"/>
            <a:ext cx="1800200" cy="590322"/>
            <a:chOff x="2215595" y="5240398"/>
            <a:chExt cx="1800200" cy="590322"/>
          </a:xfrm>
        </p:grpSpPr>
        <p:sp>
          <p:nvSpPr>
            <p:cNvPr id="71" name="テキスト ボックス 70"/>
            <p:cNvSpPr txBox="1"/>
            <p:nvPr/>
          </p:nvSpPr>
          <p:spPr>
            <a:xfrm>
              <a:off x="2215595" y="5461388"/>
              <a:ext cx="1800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750" dirty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U</a:t>
              </a:r>
              <a:r>
                <a:rPr lang="en-US" altLang="ja-JP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A</a:t>
              </a:r>
              <a:r>
                <a:rPr lang="en-US" altLang="ja-JP" sz="1750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UU</a:t>
              </a:r>
              <a:r>
                <a:rPr lang="en-US" altLang="ja-JP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CA</a:t>
              </a:r>
              <a:endParaRPr kumimoji="1" lang="ja-JP" altLang="en-US" dirty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2218333" y="5240398"/>
              <a:ext cx="14877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A</a:t>
              </a:r>
              <a:r>
                <a:rPr lang="en-US" altLang="ja-JP" sz="1750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U</a:t>
              </a:r>
              <a:r>
                <a:rPr lang="en-US" altLang="ja-JP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AA</a:t>
              </a:r>
              <a:r>
                <a:rPr lang="en-US" altLang="ja-JP" sz="1750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GU</a:t>
              </a:r>
              <a:endParaRPr kumimoji="1" lang="ja-JP" altLang="en-US" sz="1750" dirty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cxnSp>
        <p:nvCxnSpPr>
          <p:cNvPr id="59" name="直線コネクタ 58"/>
          <p:cNvCxnSpPr/>
          <p:nvPr/>
        </p:nvCxnSpPr>
        <p:spPr>
          <a:xfrm>
            <a:off x="3586940" y="3918058"/>
            <a:ext cx="1471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3593821" y="4138897"/>
            <a:ext cx="1471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3275856" y="3701961"/>
            <a:ext cx="1044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5’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281540" y="3946721"/>
            <a:ext cx="949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’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4686115" y="3573629"/>
            <a:ext cx="57606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4884255" y="3380308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5162773" y="3435724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5423158" y="3632060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5457450" y="3997418"/>
            <a:ext cx="57606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5219966" y="4172852"/>
            <a:ext cx="32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4935668" y="4289977"/>
            <a:ext cx="523695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4699393" y="4116339"/>
            <a:ext cx="35268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sz="19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7" name="四角形吹き出し 106"/>
          <p:cNvSpPr/>
          <p:nvPr/>
        </p:nvSpPr>
        <p:spPr>
          <a:xfrm rot="10800000">
            <a:off x="5940150" y="3344450"/>
            <a:ext cx="2621200" cy="1380694"/>
          </a:xfrm>
          <a:prstGeom prst="wedgeRectCallout">
            <a:avLst>
              <a:gd name="adj1" fmla="val 33731"/>
              <a:gd name="adj2" fmla="val 69471"/>
            </a:avLst>
          </a:prstGeom>
          <a:solidFill>
            <a:schemeClr val="bg1">
              <a:lumMod val="9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43" name="グループ化 42"/>
          <p:cNvGrpSpPr/>
          <p:nvPr/>
        </p:nvGrpSpPr>
        <p:grpSpPr>
          <a:xfrm>
            <a:off x="6405702" y="3764736"/>
            <a:ext cx="1806833" cy="610770"/>
            <a:chOff x="4085432" y="3608019"/>
            <a:chExt cx="1806833" cy="610770"/>
          </a:xfrm>
        </p:grpSpPr>
        <p:sp>
          <p:nvSpPr>
            <p:cNvPr id="56" name="テキスト ボックス 55"/>
            <p:cNvSpPr txBox="1"/>
            <p:nvPr/>
          </p:nvSpPr>
          <p:spPr>
            <a:xfrm>
              <a:off x="4085432" y="3608019"/>
              <a:ext cx="1800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950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CAAACC</a:t>
              </a:r>
              <a:endParaRPr kumimoji="1" lang="ja-JP" altLang="en-US" sz="1950" dirty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4092065" y="3849457"/>
              <a:ext cx="1800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750" dirty="0" smtClean="0">
                  <a:solidFill>
                    <a:srgbClr val="00B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GUUUGG</a:t>
              </a:r>
              <a:endParaRPr kumimoji="1" lang="ja-JP" altLang="en-US" sz="1750" dirty="0">
                <a:solidFill>
                  <a:srgbClr val="00B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cxnSp>
        <p:nvCxnSpPr>
          <p:cNvPr id="44" name="直線コネクタ 43"/>
          <p:cNvCxnSpPr/>
          <p:nvPr/>
        </p:nvCxnSpPr>
        <p:spPr>
          <a:xfrm>
            <a:off x="6331690" y="3970574"/>
            <a:ext cx="1471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6332221" y="4191413"/>
            <a:ext cx="1471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/>
          <p:cNvSpPr txBox="1"/>
          <p:nvPr/>
        </p:nvSpPr>
        <p:spPr>
          <a:xfrm>
            <a:off x="6014256" y="3760827"/>
            <a:ext cx="1044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5’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6019940" y="4005587"/>
            <a:ext cx="949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’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7392171" y="3598864"/>
            <a:ext cx="57606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7634761" y="3405543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7913279" y="3460959"/>
            <a:ext cx="648072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8160964" y="3669995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8163506" y="4022653"/>
            <a:ext cx="57606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sz="19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7926022" y="4198087"/>
            <a:ext cx="32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7654424" y="4321562"/>
            <a:ext cx="523695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7443549" y="4166974"/>
            <a:ext cx="35268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900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U</a:t>
            </a:r>
            <a:endParaRPr kumimoji="1" lang="ja-JP" altLang="en-US" sz="19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8" name="二等辺三角形 27"/>
          <p:cNvSpPr/>
          <p:nvPr/>
        </p:nvSpPr>
        <p:spPr>
          <a:xfrm>
            <a:off x="2259837" y="2175164"/>
            <a:ext cx="191422" cy="17711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9" name="二等辺三角形 28"/>
          <p:cNvSpPr/>
          <p:nvPr/>
        </p:nvSpPr>
        <p:spPr>
          <a:xfrm>
            <a:off x="4284891" y="2165872"/>
            <a:ext cx="191422" cy="17711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0" name="二等辺三角形 29"/>
          <p:cNvSpPr/>
          <p:nvPr/>
        </p:nvSpPr>
        <p:spPr>
          <a:xfrm>
            <a:off x="6181701" y="2165872"/>
            <a:ext cx="191422" cy="17711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839598" y="2336699"/>
            <a:ext cx="153582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osition</a:t>
            </a:r>
          </a:p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,440-3,460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867918" y="2328619"/>
            <a:ext cx="165923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osition</a:t>
            </a:r>
          </a:p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0,108-10,127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796136" y="2320735"/>
            <a:ext cx="169229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osition</a:t>
            </a:r>
          </a:p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8,316-18,335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39990" y="1050345"/>
            <a:ext cx="129650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1 </a:t>
            </a:r>
            <a:r>
              <a:rPr lang="en-US" altLang="ja-JP" sz="16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cRNA</a:t>
            </a:r>
            <a:endParaRPr kumimoji="1" lang="ja-JP" altLang="en-US" sz="16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5" name="角丸四角形 34"/>
          <p:cNvSpPr/>
          <p:nvPr/>
        </p:nvSpPr>
        <p:spPr>
          <a:xfrm>
            <a:off x="3054630" y="2046518"/>
            <a:ext cx="198493" cy="189904"/>
          </a:xfrm>
          <a:prstGeom prst="roundRect">
            <a:avLst/>
          </a:prstGeom>
          <a:solidFill>
            <a:srgbClr val="FFFF00"/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6" name="角丸四角形 35"/>
          <p:cNvSpPr/>
          <p:nvPr/>
        </p:nvSpPr>
        <p:spPr>
          <a:xfrm>
            <a:off x="7501622" y="2046518"/>
            <a:ext cx="198493" cy="189904"/>
          </a:xfrm>
          <a:prstGeom prst="roundRect">
            <a:avLst/>
          </a:prstGeom>
          <a:solidFill>
            <a:srgbClr val="FFFF00"/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72989" y="1832097"/>
            <a:ext cx="129650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</a:p>
          <a:p>
            <a:r>
              <a:rPr kumimoji="1" lang="en-US" altLang="ja-JP" sz="16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lncRNA</a:t>
            </a:r>
            <a:endParaRPr kumimoji="1" lang="ja-JP" altLang="en-US" sz="16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568461" y="1218496"/>
            <a:ext cx="13563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AAAAA</a:t>
            </a:r>
            <a:endParaRPr kumimoji="1" lang="ja-JP" altLang="en-US" sz="14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7822519" y="1985393"/>
            <a:ext cx="530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’</a:t>
            </a:r>
            <a:endParaRPr kumimoji="1" lang="ja-JP" altLang="en-US" sz="14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162327" y="1213435"/>
            <a:ext cx="530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5’</a:t>
            </a:r>
            <a:endParaRPr kumimoji="1" lang="ja-JP" altLang="en-US" sz="14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171124" y="1983401"/>
            <a:ext cx="530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5’</a:t>
            </a:r>
            <a:endParaRPr kumimoji="1" lang="ja-JP" altLang="en-US" sz="14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367232" y="1224420"/>
            <a:ext cx="530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’</a:t>
            </a:r>
            <a:endParaRPr kumimoji="1" lang="ja-JP" altLang="en-US" sz="14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9" name="テキスト ボックス 14"/>
          <p:cNvSpPr txBox="1"/>
          <p:nvPr/>
        </p:nvSpPr>
        <p:spPr>
          <a:xfrm>
            <a:off x="0" y="6430"/>
            <a:ext cx="29803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7.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3849369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69</Words>
  <Application>Microsoft Office PowerPoint</Application>
  <PresentationFormat>画面に合わせる 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Unicode MS</vt:lpstr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nori</dc:creator>
  <cp:lastModifiedBy>Yoshinori</cp:lastModifiedBy>
  <cp:revision>37</cp:revision>
  <cp:lastPrinted>2012-12-12T09:07:08Z</cp:lastPrinted>
  <dcterms:created xsi:type="dcterms:W3CDTF">2012-11-08T08:31:02Z</dcterms:created>
  <dcterms:modified xsi:type="dcterms:W3CDTF">2013-06-18T01:55:17Z</dcterms:modified>
</cp:coreProperties>
</file>